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6" r:id="rId11"/>
    <p:sldId id="267" r:id="rId12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876" autoAdjust="0"/>
    <p:restoredTop sz="94660"/>
  </p:normalViewPr>
  <p:slideViewPr>
    <p:cSldViewPr snapToGrid="0">
      <p:cViewPr>
        <p:scale>
          <a:sx n="105" d="100"/>
          <a:sy n="105" d="100"/>
        </p:scale>
        <p:origin x="-108" y="-18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48CAE-3B0C-4E2B-A663-E0389BAC26FA}" type="datetimeFigureOut">
              <a:rPr lang="en-US" smtClean="0"/>
              <a:t>8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114A8E-ACB4-495E-866C-21F5380E9F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77088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48CAE-3B0C-4E2B-A663-E0389BAC26FA}" type="datetimeFigureOut">
              <a:rPr lang="en-US" smtClean="0"/>
              <a:t>8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114A8E-ACB4-495E-866C-21F5380E9F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80138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48CAE-3B0C-4E2B-A663-E0389BAC26FA}" type="datetimeFigureOut">
              <a:rPr lang="en-US" smtClean="0"/>
              <a:t>8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114A8E-ACB4-495E-866C-21F5380E9F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6180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48CAE-3B0C-4E2B-A663-E0389BAC26FA}" type="datetimeFigureOut">
              <a:rPr lang="en-US" smtClean="0"/>
              <a:t>8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114A8E-ACB4-495E-866C-21F5380E9F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27471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48CAE-3B0C-4E2B-A663-E0389BAC26FA}" type="datetimeFigureOut">
              <a:rPr lang="en-US" smtClean="0"/>
              <a:t>8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114A8E-ACB4-495E-866C-21F5380E9F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20751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48CAE-3B0C-4E2B-A663-E0389BAC26FA}" type="datetimeFigureOut">
              <a:rPr lang="en-US" smtClean="0"/>
              <a:t>8/1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114A8E-ACB4-495E-866C-21F5380E9F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2911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48CAE-3B0C-4E2B-A663-E0389BAC26FA}" type="datetimeFigureOut">
              <a:rPr lang="en-US" smtClean="0"/>
              <a:t>8/1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114A8E-ACB4-495E-866C-21F5380E9F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46175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48CAE-3B0C-4E2B-A663-E0389BAC26FA}" type="datetimeFigureOut">
              <a:rPr lang="en-US" smtClean="0"/>
              <a:t>8/1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114A8E-ACB4-495E-866C-21F5380E9F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15533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48CAE-3B0C-4E2B-A663-E0389BAC26FA}" type="datetimeFigureOut">
              <a:rPr lang="en-US" smtClean="0"/>
              <a:t>8/1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114A8E-ACB4-495E-866C-21F5380E9F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40197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48CAE-3B0C-4E2B-A663-E0389BAC26FA}" type="datetimeFigureOut">
              <a:rPr lang="en-US" smtClean="0"/>
              <a:t>8/1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114A8E-ACB4-495E-866C-21F5380E9F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9925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48CAE-3B0C-4E2B-A663-E0389BAC26FA}" type="datetimeFigureOut">
              <a:rPr lang="en-US" smtClean="0"/>
              <a:t>8/1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114A8E-ACB4-495E-866C-21F5380E9F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64767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148CAE-3B0C-4E2B-A663-E0389BAC26FA}" type="datetimeFigureOut">
              <a:rPr lang="en-US" smtClean="0"/>
              <a:t>8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114A8E-ACB4-495E-866C-21F5380E9F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50427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41927" y="977042"/>
            <a:ext cx="9508145" cy="4903915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353568" y="341376"/>
            <a:ext cx="209702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m/z 357.2549</a:t>
            </a:r>
          </a:p>
          <a:p>
            <a:r>
              <a:rPr lang="en-US" dirty="0" smtClean="0"/>
              <a:t>Not validate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4333211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41927" y="977042"/>
            <a:ext cx="9508145" cy="4903915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73024" y="365761"/>
            <a:ext cx="270662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m/z 484.1609</a:t>
            </a:r>
          </a:p>
          <a:p>
            <a:r>
              <a:rPr lang="en-US" dirty="0" smtClean="0"/>
              <a:t>Not validate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9052595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41927" y="977042"/>
            <a:ext cx="9508145" cy="4903915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463296" y="231648"/>
            <a:ext cx="187756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m/z 652.1117</a:t>
            </a:r>
          </a:p>
          <a:p>
            <a:r>
              <a:rPr lang="en-US" dirty="0" smtClean="0"/>
              <a:t>Not validated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56037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41927" y="977042"/>
            <a:ext cx="9508145" cy="4903915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80416" y="304800"/>
            <a:ext cx="436473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m/z 884.9295</a:t>
            </a:r>
          </a:p>
          <a:p>
            <a:r>
              <a:rPr lang="en-US" dirty="0" smtClean="0"/>
              <a:t>No identification in databas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5057628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41927" y="977042"/>
            <a:ext cx="9508145" cy="4903915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475488" y="231649"/>
            <a:ext cx="455980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m/z 485.3315</a:t>
            </a:r>
          </a:p>
          <a:p>
            <a:r>
              <a:rPr lang="en-US" dirty="0"/>
              <a:t>No identification in database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8495522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41927" y="977042"/>
            <a:ext cx="9508145" cy="4903915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95072" y="316992"/>
            <a:ext cx="221894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m/z 583.2560</a:t>
            </a:r>
          </a:p>
          <a:p>
            <a:r>
              <a:rPr lang="en-US" dirty="0" smtClean="0"/>
              <a:t>May be as </a:t>
            </a:r>
            <a:r>
              <a:rPr lang="en-US" dirty="0" err="1" smtClean="0"/>
              <a:t>Biliverdin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6547104" y="2036064"/>
            <a:ext cx="136550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583.2550</a:t>
            </a:r>
          </a:p>
          <a:p>
            <a:r>
              <a:rPr lang="en-US" dirty="0" smtClean="0"/>
              <a:t>67.0542</a:t>
            </a:r>
          </a:p>
          <a:p>
            <a:r>
              <a:rPr lang="en-US" dirty="0" smtClean="0"/>
              <a:t>523.2340</a:t>
            </a:r>
            <a:endParaRPr lang="en-US" dirty="0"/>
          </a:p>
        </p:txBody>
      </p:sp>
      <p:cxnSp>
        <p:nvCxnSpPr>
          <p:cNvPr id="6" name="Straight Arrow Connector 5"/>
          <p:cNvCxnSpPr/>
          <p:nvPr/>
        </p:nvCxnSpPr>
        <p:spPr>
          <a:xfrm>
            <a:off x="8522208" y="4937760"/>
            <a:ext cx="353568" cy="40233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/>
          <p:cNvCxnSpPr/>
          <p:nvPr/>
        </p:nvCxnSpPr>
        <p:spPr>
          <a:xfrm>
            <a:off x="8887968" y="1402080"/>
            <a:ext cx="902208" cy="49987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/>
          <p:cNvCxnSpPr/>
          <p:nvPr/>
        </p:nvCxnSpPr>
        <p:spPr>
          <a:xfrm flipH="1">
            <a:off x="2133600" y="4937760"/>
            <a:ext cx="85344" cy="40233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8811061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41927" y="977042"/>
            <a:ext cx="9508145" cy="4903915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353568" y="316992"/>
            <a:ext cx="217017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m/z 229.1552</a:t>
            </a:r>
          </a:p>
          <a:p>
            <a:r>
              <a:rPr lang="en-US" dirty="0" smtClean="0"/>
              <a:t>Not validate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8965339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41927" y="977042"/>
            <a:ext cx="9508145" cy="4903915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80416" y="207264"/>
            <a:ext cx="159715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m/z 705.1837</a:t>
            </a:r>
          </a:p>
          <a:p>
            <a:r>
              <a:rPr lang="en-US" dirty="0" smtClean="0"/>
              <a:t>Not validate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6231738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41927" y="977042"/>
            <a:ext cx="9508145" cy="4903915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68224" y="170688"/>
            <a:ext cx="186537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m/z 370.0388</a:t>
            </a:r>
          </a:p>
          <a:p>
            <a:r>
              <a:rPr lang="en-US" dirty="0" smtClean="0"/>
              <a:t>Not validate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3691404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41927" y="977042"/>
            <a:ext cx="9508145" cy="4903915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414528" y="256032"/>
            <a:ext cx="232867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m/z 234.1808</a:t>
            </a:r>
          </a:p>
          <a:p>
            <a:r>
              <a:rPr lang="en-US" dirty="0" smtClean="0"/>
              <a:t>Validated as </a:t>
            </a:r>
            <a:r>
              <a:rPr lang="en-US" dirty="0" err="1" smtClean="0"/>
              <a:t>Hypusine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2743200" y="1719072"/>
            <a:ext cx="1975104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217.1550</a:t>
            </a:r>
          </a:p>
          <a:p>
            <a:r>
              <a:rPr lang="en-US" dirty="0" smtClean="0"/>
              <a:t>84.0808</a:t>
            </a:r>
          </a:p>
          <a:p>
            <a:r>
              <a:rPr lang="en-US" dirty="0" smtClean="0"/>
              <a:t>70.0651</a:t>
            </a:r>
          </a:p>
          <a:p>
            <a:r>
              <a:rPr lang="en-US" dirty="0" smtClean="0"/>
              <a:t>88.0757</a:t>
            </a:r>
          </a:p>
          <a:p>
            <a:r>
              <a:rPr lang="en-US" dirty="0" smtClean="0"/>
              <a:t>130.0869</a:t>
            </a:r>
            <a:endParaRPr lang="en-US" dirty="0"/>
          </a:p>
        </p:txBody>
      </p:sp>
      <p:cxnSp>
        <p:nvCxnSpPr>
          <p:cNvPr id="6" name="Straight Arrow Connector 5"/>
          <p:cNvCxnSpPr/>
          <p:nvPr/>
        </p:nvCxnSpPr>
        <p:spPr>
          <a:xfrm>
            <a:off x="2743200" y="4742688"/>
            <a:ext cx="134112" cy="37795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/>
          <p:cNvCxnSpPr/>
          <p:nvPr/>
        </p:nvCxnSpPr>
        <p:spPr>
          <a:xfrm flipH="1">
            <a:off x="3877056" y="4011168"/>
            <a:ext cx="365760" cy="41452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/>
          <p:cNvCxnSpPr/>
          <p:nvPr/>
        </p:nvCxnSpPr>
        <p:spPr>
          <a:xfrm>
            <a:off x="3255264" y="3767328"/>
            <a:ext cx="268224" cy="17068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/>
          <p:cNvCxnSpPr/>
          <p:nvPr/>
        </p:nvCxnSpPr>
        <p:spPr>
          <a:xfrm flipH="1">
            <a:off x="8802624" y="2657856"/>
            <a:ext cx="256032" cy="53854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/>
          <p:cNvCxnSpPr/>
          <p:nvPr/>
        </p:nvCxnSpPr>
        <p:spPr>
          <a:xfrm flipH="1">
            <a:off x="5449824" y="3389376"/>
            <a:ext cx="219456" cy="62179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 flipH="1">
            <a:off x="9595104" y="3767328"/>
            <a:ext cx="292608" cy="39014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78293607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41927" y="977042"/>
            <a:ext cx="9508145" cy="4903915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475488" y="341376"/>
            <a:ext cx="203606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m/z 210.1129</a:t>
            </a:r>
          </a:p>
          <a:p>
            <a:r>
              <a:rPr lang="en-US" dirty="0" smtClean="0"/>
              <a:t>Not validate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718900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0</TotalTime>
  <Words>59</Words>
  <Application>Microsoft Office PowerPoint</Application>
  <PresentationFormat>Custom</PresentationFormat>
  <Paragraphs>30</Paragraphs>
  <Slides>1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2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irandeep Kaur Gill</dc:creator>
  <cp:lastModifiedBy>Simina Boca</cp:lastModifiedBy>
  <cp:revision>13</cp:revision>
  <cp:lastPrinted>2018-06-27T16:14:13Z</cp:lastPrinted>
  <dcterms:created xsi:type="dcterms:W3CDTF">2018-06-26T21:42:57Z</dcterms:created>
  <dcterms:modified xsi:type="dcterms:W3CDTF">2018-08-13T20:43:37Z</dcterms:modified>
</cp:coreProperties>
</file>